
<file path=[Content_Types].xml><?xml version="1.0" encoding="utf-8"?>
<Types xmlns="http://schemas.openxmlformats.org/package/2006/content-types"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5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10"/>
    <p:restoredTop sz="94620"/>
  </p:normalViewPr>
  <p:slideViewPr>
    <p:cSldViewPr snapToGrid="0" snapToObjects="1">
      <p:cViewPr>
        <p:scale>
          <a:sx n="100" d="100"/>
          <a:sy n="100" d="100"/>
        </p:scale>
        <p:origin x="-1014" y="72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34769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42877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6005992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32334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04597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109634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0555765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841308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016672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75215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756132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CD55C-E824-E740-8AE7-FB17BB9A772A}" type="datetimeFigureOut">
              <a:rPr lang="fr-FR" smtClean="0"/>
              <a:pPr/>
              <a:t>30/08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8C329-0466-C84E-98CC-DA5B23B983C0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586036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38DA0C15-4BB7-5645-B852-5EFAD4FE97C3}"/>
              </a:ext>
            </a:extLst>
          </p:cNvPr>
          <p:cNvSpPr txBox="1"/>
          <p:nvPr/>
        </p:nvSpPr>
        <p:spPr>
          <a:xfrm>
            <a:off x="2540776" y="355988"/>
            <a:ext cx="1961422" cy="954107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19 patients </a:t>
            </a:r>
          </a:p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li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mitte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the ICU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twee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014 and 2019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AEA6C4AB-F1A6-A24C-B971-7A6021CFB94E}"/>
              </a:ext>
            </a:extLst>
          </p:cNvPr>
          <p:cNvSpPr txBox="1"/>
          <p:nvPr/>
        </p:nvSpPr>
        <p:spPr>
          <a:xfrm>
            <a:off x="2519785" y="1921619"/>
            <a:ext cx="1961422" cy="737803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CU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vivors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6 (62.1%) patients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xmlns="" id="{E9965ED5-B30F-364A-9D4D-D6A9D91EEAFF}"/>
              </a:ext>
            </a:extLst>
          </p:cNvPr>
          <p:cNvSpPr txBox="1"/>
          <p:nvPr/>
        </p:nvSpPr>
        <p:spPr>
          <a:xfrm>
            <a:off x="4685482" y="1301753"/>
            <a:ext cx="1998132" cy="738664"/>
          </a:xfrm>
          <a:prstGeom prst="rect">
            <a:avLst/>
          </a:prstGeom>
          <a:solidFill>
            <a:schemeClr val="bg1">
              <a:lumMod val="95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ed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ICU</a:t>
            </a:r>
          </a:p>
          <a:p>
            <a:pPr algn="ctr"/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3 (37.9%) patient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xmlns="" id="{A7297143-FFAC-5F45-B2F7-47EDE9984071}"/>
              </a:ext>
            </a:extLst>
          </p:cNvPr>
          <p:cNvSpPr txBox="1"/>
          <p:nvPr/>
        </p:nvSpPr>
        <p:spPr>
          <a:xfrm>
            <a:off x="4451755" y="4408688"/>
            <a:ext cx="1998134" cy="738664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 (36.0%) patient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xmlns="" id="{3470B77E-706D-F74E-AEA7-0CA19ADD8012}"/>
              </a:ext>
            </a:extLst>
          </p:cNvPr>
          <p:cNvSpPr txBox="1"/>
          <p:nvPr/>
        </p:nvSpPr>
        <p:spPr>
          <a:xfrm>
            <a:off x="335894" y="4414711"/>
            <a:ext cx="1998134" cy="738664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mption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1 (59.5%) patients</a:t>
            </a:r>
          </a:p>
        </p:txBody>
      </p:sp>
      <p:cxnSp>
        <p:nvCxnSpPr>
          <p:cNvPr id="28" name="Connecteur droit 27">
            <a:extLst>
              <a:ext uri="{FF2B5EF4-FFF2-40B4-BE49-F238E27FC236}">
                <a16:creationId xmlns:a16="http://schemas.microsoft.com/office/drawing/2014/main" xmlns="" id="{007AE39C-E5CB-E141-B708-6F6921C650B0}"/>
              </a:ext>
            </a:extLst>
          </p:cNvPr>
          <p:cNvCxnSpPr>
            <a:cxnSpLocks/>
          </p:cNvCxnSpPr>
          <p:nvPr/>
        </p:nvCxnSpPr>
        <p:spPr>
          <a:xfrm>
            <a:off x="3500496" y="1599573"/>
            <a:ext cx="1184986" cy="0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xmlns="" id="{13FE061C-56B7-4E40-ABB5-3ACDEDC45614}"/>
              </a:ext>
            </a:extLst>
          </p:cNvPr>
          <p:cNvCxnSpPr>
            <a:cxnSpLocks/>
            <a:stCxn id="6" idx="0"/>
          </p:cNvCxnSpPr>
          <p:nvPr/>
        </p:nvCxnSpPr>
        <p:spPr>
          <a:xfrm flipV="1">
            <a:off x="3500496" y="1306393"/>
            <a:ext cx="0" cy="615226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xmlns="" id="{DDDA098E-E7BB-1A12-F3BB-096761DFF149}"/>
              </a:ext>
            </a:extLst>
          </p:cNvPr>
          <p:cNvSpPr txBox="1"/>
          <p:nvPr/>
        </p:nvSpPr>
        <p:spPr>
          <a:xfrm>
            <a:off x="2519785" y="3270946"/>
            <a:ext cx="1961422" cy="523220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CU</a:t>
            </a:r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xmlns="" id="{06DC2CB7-DB8E-5027-0A35-4033511EB239}"/>
              </a:ext>
            </a:extLst>
          </p:cNvPr>
          <p:cNvCxnSpPr>
            <a:cxnSpLocks/>
          </p:cNvCxnSpPr>
          <p:nvPr/>
        </p:nvCxnSpPr>
        <p:spPr>
          <a:xfrm>
            <a:off x="1329053" y="4089388"/>
            <a:ext cx="4196283" cy="0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xmlns="" id="{8ADBE24A-771E-1655-BF3F-FC7BF5D940D4}"/>
              </a:ext>
            </a:extLst>
          </p:cNvPr>
          <p:cNvCxnSpPr>
            <a:cxnSpLocks/>
          </p:cNvCxnSpPr>
          <p:nvPr/>
        </p:nvCxnSpPr>
        <p:spPr>
          <a:xfrm flipV="1">
            <a:off x="1334961" y="4096963"/>
            <a:ext cx="0" cy="314142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xmlns="" id="{261D0963-2E6F-4D1F-4CC2-D2C798ECB953}"/>
              </a:ext>
            </a:extLst>
          </p:cNvPr>
          <p:cNvCxnSpPr>
            <a:cxnSpLocks/>
          </p:cNvCxnSpPr>
          <p:nvPr/>
        </p:nvCxnSpPr>
        <p:spPr>
          <a:xfrm flipH="1" flipV="1">
            <a:off x="5523039" y="4089170"/>
            <a:ext cx="2298" cy="319519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xmlns="" id="{A7F2E3FC-3FB6-7FFC-5803-A93DABF46975}"/>
              </a:ext>
            </a:extLst>
          </p:cNvPr>
          <p:cNvCxnSpPr>
            <a:cxnSpLocks/>
          </p:cNvCxnSpPr>
          <p:nvPr/>
        </p:nvCxnSpPr>
        <p:spPr>
          <a:xfrm flipH="1" flipV="1">
            <a:off x="3487970" y="3793250"/>
            <a:ext cx="1" cy="297820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xmlns="" id="{47AC40D6-3DC4-C7FB-063B-E12D75B8D22D}"/>
              </a:ext>
            </a:extLst>
          </p:cNvPr>
          <p:cNvSpPr txBox="1"/>
          <p:nvPr/>
        </p:nvSpPr>
        <p:spPr>
          <a:xfrm>
            <a:off x="4481207" y="5458641"/>
            <a:ext cx="1998134" cy="738664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a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CI (15-49)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xmlns="" id="{3A2007C6-9836-BA5E-7394-BC734F9C85F7}"/>
              </a:ext>
            </a:extLst>
          </p:cNvPr>
          <p:cNvSpPr txBox="1"/>
          <p:nvPr/>
        </p:nvSpPr>
        <p:spPr>
          <a:xfrm>
            <a:off x="332545" y="5458641"/>
            <a:ext cx="1998134" cy="738664"/>
          </a:xfrm>
          <a:prstGeom prst="rect">
            <a:avLst/>
          </a:prstGeom>
          <a:ln w="1905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an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all</a:t>
            </a:r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vival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71 </a:t>
            </a:r>
            <a:r>
              <a:rPr lang="fr-F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endParaRPr lang="fr-F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fr-F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%CI (376-1058)</a:t>
            </a:r>
          </a:p>
        </p:txBody>
      </p:sp>
      <p:cxnSp>
        <p:nvCxnSpPr>
          <p:cNvPr id="29" name="Connecteur droit 28">
            <a:extLst>
              <a:ext uri="{FF2B5EF4-FFF2-40B4-BE49-F238E27FC236}">
                <a16:creationId xmlns:a16="http://schemas.microsoft.com/office/drawing/2014/main" xmlns="" id="{2423F5A7-A6F4-7187-3066-E1028EFB69DE}"/>
              </a:ext>
            </a:extLst>
          </p:cNvPr>
          <p:cNvCxnSpPr>
            <a:cxnSpLocks/>
          </p:cNvCxnSpPr>
          <p:nvPr/>
        </p:nvCxnSpPr>
        <p:spPr>
          <a:xfrm flipH="1" flipV="1">
            <a:off x="1319086" y="5147352"/>
            <a:ext cx="1" cy="297820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32">
            <a:extLst>
              <a:ext uri="{FF2B5EF4-FFF2-40B4-BE49-F238E27FC236}">
                <a16:creationId xmlns:a16="http://schemas.microsoft.com/office/drawing/2014/main" xmlns="" id="{255CFE58-3BC6-188F-D991-1EDBD1602AD6}"/>
              </a:ext>
            </a:extLst>
          </p:cNvPr>
          <p:cNvCxnSpPr>
            <a:cxnSpLocks/>
          </p:cNvCxnSpPr>
          <p:nvPr/>
        </p:nvCxnSpPr>
        <p:spPr>
          <a:xfrm flipH="1" flipV="1">
            <a:off x="5450822" y="5147352"/>
            <a:ext cx="1" cy="297820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xmlns="" id="{65D93F86-845B-D293-A746-4550A260805C}"/>
              </a:ext>
            </a:extLst>
          </p:cNvPr>
          <p:cNvCxnSpPr>
            <a:cxnSpLocks/>
          </p:cNvCxnSpPr>
          <p:nvPr/>
        </p:nvCxnSpPr>
        <p:spPr>
          <a:xfrm flipV="1">
            <a:off x="3500496" y="2659422"/>
            <a:ext cx="0" cy="615226"/>
          </a:xfrm>
          <a:prstGeom prst="line">
            <a:avLst/>
          </a:prstGeom>
          <a:ln w="15875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ZoneTexte 4"/>
          <p:cNvSpPr txBox="1"/>
          <p:nvPr/>
        </p:nvSpPr>
        <p:spPr>
          <a:xfrm>
            <a:off x="335894" y="6692872"/>
            <a:ext cx="6143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1. 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ow chart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lustrating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ient’s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urse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CU admission to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mption</a:t>
            </a:r>
            <a:r>
              <a:rPr lang="fr-F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67191923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C32358BBC6A54783924BFDE8D01310" ma:contentTypeVersion="15" ma:contentTypeDescription="Create a new document." ma:contentTypeScope="" ma:versionID="3cb2caedba211555508cc8a43cb64384">
  <xsd:schema xmlns:xsd="http://www.w3.org/2001/XMLSchema" xmlns:xs="http://www.w3.org/2001/XMLSchema" xmlns:p="http://schemas.microsoft.com/office/2006/metadata/properties" xmlns:ns2="2afb718e-e481-4740-8c83-c962c2ae7a47" xmlns:ns3="f0c92a45-72c8-44ed-aaa3-c8a9987dc276" targetNamespace="http://schemas.microsoft.com/office/2006/metadata/properties" ma:root="true" ma:fieldsID="b1cc89f34e8588af1ecb7f15b6542963" ns2:_="" ns3:_="">
    <xsd:import namespace="2afb718e-e481-4740-8c83-c962c2ae7a47"/>
    <xsd:import namespace="f0c92a45-72c8-44ed-aaa3-c8a9987dc276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SearchProperties" minOccurs="0"/>
                <xsd:element ref="ns3:MediaServiceObjectDetectorVersions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lcf76f155ced4ddcb4097134ff3c332f" minOccurs="0"/>
                <xsd:element ref="ns2:TaxCatchAll" minOccurs="0"/>
                <xsd:element ref="ns3:MediaServiceDateTaken" minOccurs="0"/>
                <xsd:element ref="ns3:MediaServiceOCR" minOccurs="0"/>
                <xsd:element ref="ns3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afb718e-e481-4740-8c83-c962c2ae7a47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9" nillable="true" ma:displayName="Taxonomy Catch All Column" ma:hidden="true" ma:list="{40206d38-80b7-4fda-b169-763e61a9c543}" ma:internalName="TaxCatchAll" ma:showField="CatchAllData" ma:web="2afb718e-e481-4740-8c83-c962c2ae7a47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0c92a45-72c8-44ed-aaa3-c8a9987dc27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8" nillable="true" ma:taxonomy="true" ma:internalName="lcf76f155ced4ddcb4097134ff3c332f" ma:taxonomyFieldName="MediaServiceImageTags" ma:displayName="Image Tags" ma:readOnly="false" ma:fieldId="{5cf76f15-5ced-4ddc-b409-7134ff3c332f}" ma:taxonomyMulti="true" ma:sspId="4e3e60b7-7e0f-4d14-858b-c8d7d769770a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2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afb718e-e481-4740-8c83-c962c2ae7a47" xsi:nil="true"/>
    <lcf76f155ced4ddcb4097134ff3c332f xmlns="f0c92a45-72c8-44ed-aaa3-c8a9987dc276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7DB71F8D-93E8-41BA-8FC6-5317702172BB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E56D697-EB81-4234-AC32-13824BDCE34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afb718e-e481-4740-8c83-c962c2ae7a47"/>
    <ds:schemaRef ds:uri="f0c92a45-72c8-44ed-aaa3-c8a9987dc27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74F38C4-6E45-4ABF-9C78-CBBA21BCF844}">
  <ds:schemaRefs>
    <ds:schemaRef ds:uri="http://schemas.microsoft.com/office/2006/metadata/properties"/>
    <ds:schemaRef ds:uri="http://schemas.microsoft.com/office/infopath/2007/PartnerControls"/>
    <ds:schemaRef ds:uri="2afb718e-e481-4740-8c83-c962c2ae7a47"/>
    <ds:schemaRef ds:uri="f0c92a45-72c8-44ed-aaa3-c8a9987dc276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4</TotalTime>
  <Words>81</Words>
  <Application>Microsoft Office PowerPoint</Application>
  <PresentationFormat>Custom</PresentationFormat>
  <Paragraphs>2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exiane Blanc</dc:creator>
  <cp:lastModifiedBy>ARUN</cp:lastModifiedBy>
  <cp:revision>28</cp:revision>
  <dcterms:created xsi:type="dcterms:W3CDTF">2022-06-05T09:22:07Z</dcterms:created>
  <dcterms:modified xsi:type="dcterms:W3CDTF">2024-08-30T13:09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C32358BBC6A54783924BFDE8D01310</vt:lpwstr>
  </property>
</Properties>
</file>